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61" r:id="rId3"/>
    <p:sldId id="263" r:id="rId4"/>
  </p:sldIdLst>
  <p:sldSz cx="12192000" cy="6858000"/>
  <p:notesSz cx="6735763" cy="98663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03" autoAdjust="0"/>
    <p:restoredTop sz="94660"/>
  </p:normalViewPr>
  <p:slideViewPr>
    <p:cSldViewPr snapToGrid="0">
      <p:cViewPr varScale="1">
        <p:scale>
          <a:sx n="87" d="100"/>
          <a:sy n="87" d="100"/>
        </p:scale>
        <p:origin x="67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4" Type="http://schemas.openxmlformats.org/officeDocument/2006/relationships/image" Target="../media/image6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4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B726E2-C8B2-4351-9148-6F2C789A2009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9F0FAB-B950-47D6-95E3-AE3716947C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44698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445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180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4444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2236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867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7977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1629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8158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8049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0056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6597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B83162-224D-425B-92CD-8985D6C2E12D}" type="datetimeFigureOut">
              <a:rPr lang="zh-CN" altLang="en-US" smtClean="0"/>
              <a:t>2021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D1FA9-83A7-4E69-9273-4DB47E98B3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4192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10" Type="http://schemas.openxmlformats.org/officeDocument/2006/relationships/image" Target="../media/image6.emf"/><Relationship Id="rId4" Type="http://schemas.openxmlformats.org/officeDocument/2006/relationships/image" Target="../media/image3.emf"/><Relationship Id="rId9" Type="http://schemas.openxmlformats.org/officeDocument/2006/relationships/oleObject" Target="../embeddings/oleObject6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8.emf"/><Relationship Id="rId11" Type="http://schemas.openxmlformats.org/officeDocument/2006/relationships/image" Target="../media/image11.jpeg"/><Relationship Id="rId5" Type="http://schemas.openxmlformats.org/officeDocument/2006/relationships/oleObject" Target="../embeddings/oleObject8.bin"/><Relationship Id="rId10" Type="http://schemas.openxmlformats.org/officeDocument/2006/relationships/image" Target="../media/image10.emf"/><Relationship Id="rId4" Type="http://schemas.openxmlformats.org/officeDocument/2006/relationships/image" Target="../media/image7.emf"/><Relationship Id="rId9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0" y="6047875"/>
            <a:ext cx="12192000" cy="810126"/>
          </a:xfrm>
        </p:spPr>
        <p:txBody>
          <a:bodyPr>
            <a:normAutofit fontScale="55000" lnSpcReduction="20000"/>
          </a:bodyPr>
          <a:lstStyle/>
          <a:p>
            <a:pPr marL="0" indent="0">
              <a:lnSpc>
                <a:spcPct val="170000"/>
              </a:lnSpc>
              <a:buNone/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LASSO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x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gression analysis to construct prognostic signatures for LGG. (A)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SO coefficient spectrum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rate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coefficient distribution map for a logarithmic (λ) sequence.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Selecting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est parameters for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GG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LASSO model (λ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70000"/>
              </a:lnSpc>
              <a:buNone/>
            </a:pP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3703637"/>
              </p:ext>
            </p:extLst>
          </p:nvPr>
        </p:nvGraphicFramePr>
        <p:xfrm>
          <a:off x="6151857" y="618014"/>
          <a:ext cx="3921847" cy="39218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41" name="Acrobat Document" r:id="rId3" imgW="4800509" imgH="4800363" progId="Acrobat.Document.11">
                  <p:embed/>
                </p:oleObj>
              </mc:Choice>
              <mc:Fallback>
                <p:oleObj name="Acrobat Document" r:id="rId3" imgW="4800509" imgH="4800363" progId="Acrobat.Documen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151857" y="618014"/>
                        <a:ext cx="3921847" cy="39218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5673895"/>
              </p:ext>
            </p:extLst>
          </p:nvPr>
        </p:nvGraphicFramePr>
        <p:xfrm>
          <a:off x="1596539" y="618014"/>
          <a:ext cx="3921847" cy="39218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42" name="Acrobat Document" r:id="rId5" imgW="4800509" imgH="4800363" progId="Acrobat.Document.11">
                  <p:embed/>
                </p:oleObj>
              </mc:Choice>
              <mc:Fallback>
                <p:oleObj name="Acrobat Document" r:id="rId5" imgW="4800509" imgH="4800363" progId="Acrobat.Documen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96539" y="618014"/>
                        <a:ext cx="3921847" cy="39218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本框 7"/>
          <p:cNvSpPr txBox="1"/>
          <p:nvPr/>
        </p:nvSpPr>
        <p:spPr>
          <a:xfrm>
            <a:off x="1062610" y="801775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(A)</a:t>
            </a:r>
            <a:endParaRPr lang="zh-CN" altLang="en-US" dirty="0"/>
          </a:p>
        </p:txBody>
      </p:sp>
      <p:sp>
        <p:nvSpPr>
          <p:cNvPr id="9" name="文本框 8"/>
          <p:cNvSpPr txBox="1"/>
          <p:nvPr/>
        </p:nvSpPr>
        <p:spPr>
          <a:xfrm>
            <a:off x="5743724" y="801775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(B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681465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171247" y="5947693"/>
            <a:ext cx="11182553" cy="983673"/>
          </a:xfrm>
        </p:spPr>
        <p:txBody>
          <a:bodyPr>
            <a:normAutofit fontScale="47500" lnSpcReduction="20000"/>
          </a:bodyPr>
          <a:lstStyle/>
          <a:p>
            <a:pPr marL="0" indent="0">
              <a:lnSpc>
                <a:spcPct val="170000"/>
              </a:lnSpc>
              <a:buNone/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Characteristics of prognostic gene signatures. (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s of OS status, OS and risk score i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CGA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hort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B)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s of OS status, OS an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sk score in the CGGA cohort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, D) Heat map of the seven-FRGs expressions profiles in the prognostic signature of TCGA cohort (C) and the CGGA cohort (D)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对象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7746291"/>
              </p:ext>
            </p:extLst>
          </p:nvPr>
        </p:nvGraphicFramePr>
        <p:xfrm>
          <a:off x="6390626" y="359597"/>
          <a:ext cx="5597291" cy="21197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78" name="Acrobat Document" r:id="rId3" imgW="6857708" imgH="2399992" progId="Acrobat.Document.11">
                  <p:embed/>
                </p:oleObj>
              </mc:Choice>
              <mc:Fallback>
                <p:oleObj name="Acrobat Document" r:id="rId3" imgW="6857708" imgH="2399992" progId="Acrobat.Document.11">
                  <p:embed/>
                  <p:pic>
                    <p:nvPicPr>
                      <p:cNvPr id="8" name="对象 7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90626" y="359597"/>
                        <a:ext cx="5597291" cy="21197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0474161"/>
              </p:ext>
            </p:extLst>
          </p:nvPr>
        </p:nvGraphicFramePr>
        <p:xfrm>
          <a:off x="6390625" y="3346399"/>
          <a:ext cx="5597291" cy="21197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79" name="Acrobat Document" r:id="rId5" imgW="6857708" imgH="2399992" progId="Acrobat.Document.11">
                  <p:embed/>
                </p:oleObj>
              </mc:Choice>
              <mc:Fallback>
                <p:oleObj name="Acrobat Document" r:id="rId5" imgW="6857708" imgH="2399992" progId="Acrobat.Document.11">
                  <p:embed/>
                  <p:pic>
                    <p:nvPicPr>
                      <p:cNvPr id="9" name="对象 8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390625" y="3346399"/>
                        <a:ext cx="5597291" cy="21197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9588003"/>
              </p:ext>
            </p:extLst>
          </p:nvPr>
        </p:nvGraphicFramePr>
        <p:xfrm>
          <a:off x="171247" y="359597"/>
          <a:ext cx="6056415" cy="21197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80" name="Acrobat Document" r:id="rId7" imgW="6857865" imgH="2400300" progId="Acrobat.Document.11">
                  <p:embed/>
                </p:oleObj>
              </mc:Choice>
              <mc:Fallback>
                <p:oleObj name="Acrobat Document" r:id="rId7" imgW="6857865" imgH="2400300" progId="Acrobat.Documen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1247" y="359597"/>
                        <a:ext cx="6056415" cy="21197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3432321"/>
              </p:ext>
            </p:extLst>
          </p:nvPr>
        </p:nvGraphicFramePr>
        <p:xfrm>
          <a:off x="152447" y="3333239"/>
          <a:ext cx="6094014" cy="21329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81" name="Acrobat Document" r:id="rId9" imgW="6857865" imgH="2400300" progId="Acrobat.Document.11">
                  <p:embed/>
                </p:oleObj>
              </mc:Choice>
              <mc:Fallback>
                <p:oleObj name="Acrobat Document" r:id="rId9" imgW="6857865" imgH="2400300" progId="Acrobat.Documen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52447" y="3333239"/>
                        <a:ext cx="6094014" cy="21329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文本框 8"/>
          <p:cNvSpPr txBox="1"/>
          <p:nvPr/>
        </p:nvSpPr>
        <p:spPr>
          <a:xfrm>
            <a:off x="6390625" y="2794627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33648" y="174931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71247" y="2789385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390625" y="174931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86754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对象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2138628"/>
              </p:ext>
            </p:extLst>
          </p:nvPr>
        </p:nvGraphicFramePr>
        <p:xfrm>
          <a:off x="4890908" y="1554809"/>
          <a:ext cx="6154533" cy="2154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0" name="Acrobat Document" r:id="rId3" imgW="6857865" imgH="2400300" progId="Acrobat.Document.11">
                  <p:embed/>
                </p:oleObj>
              </mc:Choice>
              <mc:Fallback>
                <p:oleObj name="Acrobat Document" r:id="rId3" imgW="6857865" imgH="2400300" progId="Acrobat.Documen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90908" y="1554809"/>
                        <a:ext cx="6154533" cy="2154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对象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9625618"/>
              </p:ext>
            </p:extLst>
          </p:nvPr>
        </p:nvGraphicFramePr>
        <p:xfrm>
          <a:off x="4890908" y="-97459"/>
          <a:ext cx="6154533" cy="2154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1" name="Acrobat Document" r:id="rId5" imgW="6857865" imgH="2400300" progId="Acrobat.Document.11">
                  <p:embed/>
                </p:oleObj>
              </mc:Choice>
              <mc:Fallback>
                <p:oleObj name="Acrobat Document" r:id="rId5" imgW="6857865" imgH="2400300" progId="Acrobat.Documen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90908" y="-97459"/>
                        <a:ext cx="6154533" cy="2154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171247" y="5947693"/>
            <a:ext cx="11182553" cy="983673"/>
          </a:xfrm>
        </p:spPr>
        <p:txBody>
          <a:bodyPr>
            <a:normAutofit fontScale="47500" lnSpcReduction="20000"/>
          </a:bodyPr>
          <a:lstStyle/>
          <a:p>
            <a:pPr marL="0" indent="0">
              <a:lnSpc>
                <a:spcPct val="170000"/>
              </a:lnSpc>
              <a:buNone/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External validation of the 7-FRGs signature model in the CGGA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hort-2 (n=420)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curves for the OS of patients in the high-risk group and low-risk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AUC of time-dependent ROC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rves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 of the risk score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D) Th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s of OS status, OS and risk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ore. (E)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 map of the seven-FRGs expressions profiles in the prognostic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ture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425663" y="1871962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425663" y="0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33648" y="2876646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4797735"/>
              </p:ext>
            </p:extLst>
          </p:nvPr>
        </p:nvGraphicFramePr>
        <p:xfrm>
          <a:off x="717220" y="174931"/>
          <a:ext cx="3094015" cy="28127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2" name="Acrobat Document" r:id="rId7" imgW="3771866" imgH="3429000" progId="Acrobat.Document.11">
                  <p:embed/>
                </p:oleObj>
              </mc:Choice>
              <mc:Fallback>
                <p:oleObj name="Acrobat Document" r:id="rId7" imgW="3771866" imgH="3429000" progId="Acrobat.Documen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17220" y="174931"/>
                        <a:ext cx="3094015" cy="28127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文本框 9"/>
          <p:cNvSpPr txBox="1"/>
          <p:nvPr/>
        </p:nvSpPr>
        <p:spPr>
          <a:xfrm>
            <a:off x="133648" y="174931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对象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7355052"/>
              </p:ext>
            </p:extLst>
          </p:nvPr>
        </p:nvGraphicFramePr>
        <p:xfrm>
          <a:off x="4890908" y="3630974"/>
          <a:ext cx="6154533" cy="2154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3" name="Acrobat Document" r:id="rId9" imgW="6857865" imgH="2400300" progId="Acrobat.Document.11">
                  <p:embed/>
                </p:oleObj>
              </mc:Choice>
              <mc:Fallback>
                <p:oleObj name="Acrobat Document" r:id="rId9" imgW="6857865" imgH="2400300" progId="Acrobat.Documen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890908" y="3630974"/>
                        <a:ext cx="6154533" cy="2154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8" name="图片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7220" y="3053191"/>
            <a:ext cx="2998725" cy="2731870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4425663" y="3559258"/>
            <a:ext cx="434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6666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06</TotalTime>
  <Words>236</Words>
  <Application>Microsoft Office PowerPoint</Application>
  <PresentationFormat>宽屏</PresentationFormat>
  <Paragraphs>14</Paragraphs>
  <Slides>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主题​​</vt:lpstr>
      <vt:lpstr>Acrobat Document</vt:lpstr>
      <vt:lpstr>Adobe Acrobat Document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jason</dc:creator>
  <cp:lastModifiedBy>jason 赵</cp:lastModifiedBy>
  <cp:revision>96</cp:revision>
  <cp:lastPrinted>2021-04-14T14:57:05Z</cp:lastPrinted>
  <dcterms:created xsi:type="dcterms:W3CDTF">2021-02-13T06:37:22Z</dcterms:created>
  <dcterms:modified xsi:type="dcterms:W3CDTF">2021-09-26T03:36:56Z</dcterms:modified>
</cp:coreProperties>
</file>